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31" d="100"/>
          <a:sy n="131" d="100"/>
        </p:scale>
        <p:origin x="101" y="1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A5CD64-1D89-A1CC-3DF2-9E2A38EF71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6B3EC1-F9C8-0874-A26E-2C27D35DA3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8F2547-F451-B1A8-237A-A370B0C36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BBBEE9-500D-FC30-99FF-0556500F0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AA93E6-89DA-E6AB-142F-26082A321A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8188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3D796D-D12D-55A4-0212-7C01E0E6AE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504A8F-3A08-639C-C355-CA0F241E23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1B73F6-4568-F780-F23E-D321FDE674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A2DBE9-CFBF-675F-3293-E9F876D32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192ABC-3DD2-62BC-A791-B6CD542E18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608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D94A151-A37F-571B-13AD-E300901F41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CC301E-B2EC-FBFA-CF7A-9BA2129968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73EABE-7129-9105-D2BF-09D8CBC67A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C13189-7F3A-B583-2897-C0DA4A9CD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855629-2C5D-C7C9-8AD7-4FB7EE9DC9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944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E0ED4F-61F0-DEF0-8AE4-D0E6D594E1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E139DB-67F2-3B81-04BE-6AD14CDF3D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D5E64E-C4F3-A3A4-5AB0-720DE4DBD4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AC5B-721D-8A97-0B19-EB1E0BDCC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72E5CC-2915-B0FC-0AAF-CBB3E78FB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946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CF2C9D-8FCC-A08B-FF94-860EE56EE1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A2AEC4-0A0F-C646-E6C1-2228314EAF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3A4EFE-9533-28B3-E523-BA49956FA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4EB92B-0131-6C71-13B8-D1F7668F1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286B20-4CA3-9E69-E225-B699A0230B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08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30C785-A796-7355-F868-CD70D4D1B6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0778F8-3A49-E49B-79FB-6569BA478D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93C356-F002-8CE6-B2B7-0EC77620DB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7EA2CD-CAF6-B061-1B32-46C0B280C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7681DDD-FD6F-1D6C-120B-9D3A876891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66C44E-C5B1-0CAE-D177-CCC6D079EB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888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109978-93E9-DB62-1E07-31428E633C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007408-434E-322E-D76C-D935D264D4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CE4AE7-B877-19A9-132A-7EA4F4B46A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257CDE-4137-E37B-C4D6-39F594024F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194FAE1-E72E-DF30-1A5B-2CC05F5256E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E4DA04-3FD3-EAFD-835A-752C3BD32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CCEE6DA-3D32-B106-C483-FC877148E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3030446-2C7B-A59D-6197-C929532B35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12628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7855D5-1C73-97E4-16B0-F7C58FF6D3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FFB0E0-4979-2E98-7EBB-B9B72ABE8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8B67CF-9343-B312-2C34-7CC12189D8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67D5ACE-C544-1863-04E3-A3444898B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5235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7A9B21-4771-5D46-8C5D-27EE96CE1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5C9FED3-BC45-2474-D0B6-612D9E87E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3EDC1F9-6136-7797-7095-A12618461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083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D43509-07BD-98C7-DFA4-B1ED313C6C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DEAB93-AACA-2798-6A76-3CF8A85C05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546471-8B84-8515-8BC7-7D21F795E84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5A5015-D49D-B85D-E737-F36C0D72DA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434669-1512-9079-A465-36A7560E98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D43DFD-669A-EC3F-3DEE-1C6F1C2A4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0218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B1F6BD-E6F9-3FB6-81BD-F9AE1CC06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978EF9F-F7FE-152D-A986-17B75397D7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4E6126D-CAF6-7FC4-C70C-43E60A9729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0B2587-D213-2680-E64A-3F202DC93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1A740A-47B2-7610-48D3-062A3D2EBB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892457B-8AD2-F37A-FBB5-7324DCE26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0237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2FD9871-AF7B-5C6E-CD5B-B91336DE5F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4BA8DD-FD4F-C8C2-E651-86D209403D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A35873-AAFB-07B2-54B0-A51C136638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37E837-E51E-4BA8-B560-56FF252EC6AA}" type="datetimeFigureOut">
              <a:rPr lang="en-US" smtClean="0"/>
              <a:t>6/2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88CBFC-BD15-FCC7-5227-69D751120D2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D3C86-0A13-AC73-9E40-2634E6FA69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0E3A85-3EEA-445D-AF86-7DDDB6415B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6636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1413990-562D-121B-C316-C635C15772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019" y="890682"/>
            <a:ext cx="10949962" cy="358902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B79BB471-D3F3-5E21-61C3-B0E20C141946}"/>
              </a:ext>
            </a:extLst>
          </p:cNvPr>
          <p:cNvSpPr txBox="1"/>
          <p:nvPr/>
        </p:nvSpPr>
        <p:spPr>
          <a:xfrm>
            <a:off x="88668" y="4399058"/>
            <a:ext cx="1129764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. No significant differences in the density of motor neurons (A) or density of motor neurons (MNs) with cytoplasmic p62-immunoreactive inclusions were identified in the hypoglossal nucleus (B-E) of ALS cases with short (&lt;2 years) or longer (4-7 years) disease durations. Data are presented as mean ± SE. SLI = skein-like inclusions.”</a:t>
            </a:r>
          </a:p>
        </p:txBody>
      </p:sp>
    </p:spTree>
    <p:extLst>
      <p:ext uri="{BB962C8B-B14F-4D97-AF65-F5344CB8AC3E}">
        <p14:creationId xmlns:p14="http://schemas.microsoft.com/office/powerpoint/2010/main" val="1857047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bel, Raymond</dc:creator>
  <cp:lastModifiedBy>Sobel, Raymond</cp:lastModifiedBy>
  <cp:revision>3</cp:revision>
  <dcterms:created xsi:type="dcterms:W3CDTF">2023-06-22T17:38:54Z</dcterms:created>
  <dcterms:modified xsi:type="dcterms:W3CDTF">2023-06-22T17:44:21Z</dcterms:modified>
</cp:coreProperties>
</file>